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</p:sldIdLst>
  <p:sldSz cx="15544800" cy="11522075"/>
  <p:notesSz cx="6950075" cy="92360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6353" autoAdjust="0"/>
  </p:normalViewPr>
  <p:slideViewPr>
    <p:cSldViewPr snapToGrid="0">
      <p:cViewPr varScale="1">
        <p:scale>
          <a:sx n="63" d="100"/>
          <a:sy n="63" d="100"/>
        </p:scale>
        <p:origin x="114" y="1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65860" y="1885674"/>
            <a:ext cx="13213080" cy="4011389"/>
          </a:xfrm>
        </p:spPr>
        <p:txBody>
          <a:bodyPr anchor="b"/>
          <a:lstStyle>
            <a:lvl1pPr algn="ctr">
              <a:defRPr sz="1008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943100" y="6051758"/>
            <a:ext cx="11658600" cy="2781833"/>
          </a:xfrm>
        </p:spPr>
        <p:txBody>
          <a:bodyPr/>
          <a:lstStyle>
            <a:lvl1pPr marL="0" indent="0" algn="ctr">
              <a:buNone/>
              <a:defRPr sz="4032"/>
            </a:lvl1pPr>
            <a:lvl2pPr marL="768142" indent="0" algn="ctr">
              <a:buNone/>
              <a:defRPr sz="3360"/>
            </a:lvl2pPr>
            <a:lvl3pPr marL="1536283" indent="0" algn="ctr">
              <a:buNone/>
              <a:defRPr sz="3024"/>
            </a:lvl3pPr>
            <a:lvl4pPr marL="2304425" indent="0" algn="ctr">
              <a:buNone/>
              <a:defRPr sz="2688"/>
            </a:lvl4pPr>
            <a:lvl5pPr marL="3072567" indent="0" algn="ctr">
              <a:buNone/>
              <a:defRPr sz="2688"/>
            </a:lvl5pPr>
            <a:lvl6pPr marL="3840709" indent="0" algn="ctr">
              <a:buNone/>
              <a:defRPr sz="2688"/>
            </a:lvl6pPr>
            <a:lvl7pPr marL="4608850" indent="0" algn="ctr">
              <a:buNone/>
              <a:defRPr sz="2688"/>
            </a:lvl7pPr>
            <a:lvl8pPr marL="5376992" indent="0" algn="ctr">
              <a:buNone/>
              <a:defRPr sz="2688"/>
            </a:lvl8pPr>
            <a:lvl9pPr marL="6145134" indent="0" algn="ctr">
              <a:buNone/>
              <a:defRPr sz="2688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29006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345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124248" y="613444"/>
            <a:ext cx="3351848" cy="976442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68706" y="613444"/>
            <a:ext cx="9861233" cy="9764426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3621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5759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60610" y="2872521"/>
            <a:ext cx="13407390" cy="4792862"/>
          </a:xfrm>
        </p:spPr>
        <p:txBody>
          <a:bodyPr anchor="b"/>
          <a:lstStyle>
            <a:lvl1pPr>
              <a:defRPr sz="1008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0610" y="7710725"/>
            <a:ext cx="13407390" cy="2520453"/>
          </a:xfrm>
        </p:spPr>
        <p:txBody>
          <a:bodyPr/>
          <a:lstStyle>
            <a:lvl1pPr marL="0" indent="0">
              <a:buNone/>
              <a:defRPr sz="4032">
                <a:solidFill>
                  <a:schemeClr val="tx1"/>
                </a:solidFill>
              </a:defRPr>
            </a:lvl1pPr>
            <a:lvl2pPr marL="768142" indent="0">
              <a:buNone/>
              <a:defRPr sz="3360">
                <a:solidFill>
                  <a:schemeClr val="tx1">
                    <a:tint val="75000"/>
                  </a:schemeClr>
                </a:solidFill>
              </a:defRPr>
            </a:lvl2pPr>
            <a:lvl3pPr marL="1536283" indent="0">
              <a:buNone/>
              <a:defRPr sz="3024">
                <a:solidFill>
                  <a:schemeClr val="tx1">
                    <a:tint val="75000"/>
                  </a:schemeClr>
                </a:solidFill>
              </a:defRPr>
            </a:lvl3pPr>
            <a:lvl4pPr marL="2304425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4pPr>
            <a:lvl5pPr marL="3072567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5pPr>
            <a:lvl6pPr marL="3840709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6pPr>
            <a:lvl7pPr marL="4608850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7pPr>
            <a:lvl8pPr marL="5376992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8pPr>
            <a:lvl9pPr marL="6145134" indent="0">
              <a:buNone/>
              <a:defRPr sz="268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43752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68705" y="3067219"/>
            <a:ext cx="6606540" cy="73106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69555" y="3067219"/>
            <a:ext cx="6606540" cy="731065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2189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613446"/>
            <a:ext cx="13407390" cy="22270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70731" y="2824510"/>
            <a:ext cx="6576178" cy="1384248"/>
          </a:xfrm>
        </p:spPr>
        <p:txBody>
          <a:bodyPr anchor="b"/>
          <a:lstStyle>
            <a:lvl1pPr marL="0" indent="0">
              <a:buNone/>
              <a:defRPr sz="4032" b="1"/>
            </a:lvl1pPr>
            <a:lvl2pPr marL="768142" indent="0">
              <a:buNone/>
              <a:defRPr sz="3360" b="1"/>
            </a:lvl2pPr>
            <a:lvl3pPr marL="1536283" indent="0">
              <a:buNone/>
              <a:defRPr sz="3024" b="1"/>
            </a:lvl3pPr>
            <a:lvl4pPr marL="2304425" indent="0">
              <a:buNone/>
              <a:defRPr sz="2688" b="1"/>
            </a:lvl4pPr>
            <a:lvl5pPr marL="3072567" indent="0">
              <a:buNone/>
              <a:defRPr sz="2688" b="1"/>
            </a:lvl5pPr>
            <a:lvl6pPr marL="3840709" indent="0">
              <a:buNone/>
              <a:defRPr sz="2688" b="1"/>
            </a:lvl6pPr>
            <a:lvl7pPr marL="4608850" indent="0">
              <a:buNone/>
              <a:defRPr sz="2688" b="1"/>
            </a:lvl7pPr>
            <a:lvl8pPr marL="5376992" indent="0">
              <a:buNone/>
              <a:defRPr sz="2688" b="1"/>
            </a:lvl8pPr>
            <a:lvl9pPr marL="6145134" indent="0">
              <a:buNone/>
              <a:defRPr sz="268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70731" y="4208758"/>
            <a:ext cx="6576178" cy="619044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69556" y="2824510"/>
            <a:ext cx="6608565" cy="1384248"/>
          </a:xfrm>
        </p:spPr>
        <p:txBody>
          <a:bodyPr anchor="b"/>
          <a:lstStyle>
            <a:lvl1pPr marL="0" indent="0">
              <a:buNone/>
              <a:defRPr sz="4032" b="1"/>
            </a:lvl1pPr>
            <a:lvl2pPr marL="768142" indent="0">
              <a:buNone/>
              <a:defRPr sz="3360" b="1"/>
            </a:lvl2pPr>
            <a:lvl3pPr marL="1536283" indent="0">
              <a:buNone/>
              <a:defRPr sz="3024" b="1"/>
            </a:lvl3pPr>
            <a:lvl4pPr marL="2304425" indent="0">
              <a:buNone/>
              <a:defRPr sz="2688" b="1"/>
            </a:lvl4pPr>
            <a:lvl5pPr marL="3072567" indent="0">
              <a:buNone/>
              <a:defRPr sz="2688" b="1"/>
            </a:lvl5pPr>
            <a:lvl6pPr marL="3840709" indent="0">
              <a:buNone/>
              <a:defRPr sz="2688" b="1"/>
            </a:lvl6pPr>
            <a:lvl7pPr marL="4608850" indent="0">
              <a:buNone/>
              <a:defRPr sz="2688" b="1"/>
            </a:lvl7pPr>
            <a:lvl8pPr marL="5376992" indent="0">
              <a:buNone/>
              <a:defRPr sz="2688" b="1"/>
            </a:lvl8pPr>
            <a:lvl9pPr marL="6145134" indent="0">
              <a:buNone/>
              <a:defRPr sz="2688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69556" y="4208758"/>
            <a:ext cx="6608565" cy="619044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500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598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8960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768138"/>
            <a:ext cx="5013603" cy="2688484"/>
          </a:xfrm>
        </p:spPr>
        <p:txBody>
          <a:bodyPr anchor="b"/>
          <a:lstStyle>
            <a:lvl1pPr>
              <a:defRPr sz="537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608565" y="1658968"/>
            <a:ext cx="7869555" cy="8188141"/>
          </a:xfrm>
        </p:spPr>
        <p:txBody>
          <a:bodyPr/>
          <a:lstStyle>
            <a:lvl1pPr>
              <a:defRPr sz="5376"/>
            </a:lvl1pPr>
            <a:lvl2pPr>
              <a:defRPr sz="4704"/>
            </a:lvl2pPr>
            <a:lvl3pPr>
              <a:defRPr sz="4032"/>
            </a:lvl3pPr>
            <a:lvl4pPr>
              <a:defRPr sz="3360"/>
            </a:lvl4pPr>
            <a:lvl5pPr>
              <a:defRPr sz="3360"/>
            </a:lvl5pPr>
            <a:lvl6pPr>
              <a:defRPr sz="3360"/>
            </a:lvl6pPr>
            <a:lvl7pPr>
              <a:defRPr sz="3360"/>
            </a:lvl7pPr>
            <a:lvl8pPr>
              <a:defRPr sz="3360"/>
            </a:lvl8pPr>
            <a:lvl9pPr>
              <a:defRPr sz="336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3456622"/>
            <a:ext cx="5013603" cy="6403821"/>
          </a:xfrm>
        </p:spPr>
        <p:txBody>
          <a:bodyPr/>
          <a:lstStyle>
            <a:lvl1pPr marL="0" indent="0">
              <a:buNone/>
              <a:defRPr sz="2688"/>
            </a:lvl1pPr>
            <a:lvl2pPr marL="768142" indent="0">
              <a:buNone/>
              <a:defRPr sz="2352"/>
            </a:lvl2pPr>
            <a:lvl3pPr marL="1536283" indent="0">
              <a:buNone/>
              <a:defRPr sz="2016"/>
            </a:lvl3pPr>
            <a:lvl4pPr marL="2304425" indent="0">
              <a:buNone/>
              <a:defRPr sz="1680"/>
            </a:lvl4pPr>
            <a:lvl5pPr marL="3072567" indent="0">
              <a:buNone/>
              <a:defRPr sz="1680"/>
            </a:lvl5pPr>
            <a:lvl6pPr marL="3840709" indent="0">
              <a:buNone/>
              <a:defRPr sz="1680"/>
            </a:lvl6pPr>
            <a:lvl7pPr marL="4608850" indent="0">
              <a:buNone/>
              <a:defRPr sz="1680"/>
            </a:lvl7pPr>
            <a:lvl8pPr marL="5376992" indent="0">
              <a:buNone/>
              <a:defRPr sz="1680"/>
            </a:lvl8pPr>
            <a:lvl9pPr marL="6145134" indent="0">
              <a:buNone/>
              <a:defRPr sz="168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503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70730" y="768138"/>
            <a:ext cx="5013603" cy="2688484"/>
          </a:xfrm>
        </p:spPr>
        <p:txBody>
          <a:bodyPr anchor="b"/>
          <a:lstStyle>
            <a:lvl1pPr>
              <a:defRPr sz="5376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608565" y="1658968"/>
            <a:ext cx="7869555" cy="8188141"/>
          </a:xfrm>
        </p:spPr>
        <p:txBody>
          <a:bodyPr anchor="t"/>
          <a:lstStyle>
            <a:lvl1pPr marL="0" indent="0">
              <a:buNone/>
              <a:defRPr sz="5376"/>
            </a:lvl1pPr>
            <a:lvl2pPr marL="768142" indent="0">
              <a:buNone/>
              <a:defRPr sz="4704"/>
            </a:lvl2pPr>
            <a:lvl3pPr marL="1536283" indent="0">
              <a:buNone/>
              <a:defRPr sz="4032"/>
            </a:lvl3pPr>
            <a:lvl4pPr marL="2304425" indent="0">
              <a:buNone/>
              <a:defRPr sz="3360"/>
            </a:lvl4pPr>
            <a:lvl5pPr marL="3072567" indent="0">
              <a:buNone/>
              <a:defRPr sz="3360"/>
            </a:lvl5pPr>
            <a:lvl6pPr marL="3840709" indent="0">
              <a:buNone/>
              <a:defRPr sz="3360"/>
            </a:lvl6pPr>
            <a:lvl7pPr marL="4608850" indent="0">
              <a:buNone/>
              <a:defRPr sz="3360"/>
            </a:lvl7pPr>
            <a:lvl8pPr marL="5376992" indent="0">
              <a:buNone/>
              <a:defRPr sz="3360"/>
            </a:lvl8pPr>
            <a:lvl9pPr marL="6145134" indent="0">
              <a:buNone/>
              <a:defRPr sz="336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70730" y="3456622"/>
            <a:ext cx="5013603" cy="6403821"/>
          </a:xfrm>
        </p:spPr>
        <p:txBody>
          <a:bodyPr/>
          <a:lstStyle>
            <a:lvl1pPr marL="0" indent="0">
              <a:buNone/>
              <a:defRPr sz="2688"/>
            </a:lvl1pPr>
            <a:lvl2pPr marL="768142" indent="0">
              <a:buNone/>
              <a:defRPr sz="2352"/>
            </a:lvl2pPr>
            <a:lvl3pPr marL="1536283" indent="0">
              <a:buNone/>
              <a:defRPr sz="2016"/>
            </a:lvl3pPr>
            <a:lvl4pPr marL="2304425" indent="0">
              <a:buNone/>
              <a:defRPr sz="1680"/>
            </a:lvl4pPr>
            <a:lvl5pPr marL="3072567" indent="0">
              <a:buNone/>
              <a:defRPr sz="1680"/>
            </a:lvl5pPr>
            <a:lvl6pPr marL="3840709" indent="0">
              <a:buNone/>
              <a:defRPr sz="1680"/>
            </a:lvl6pPr>
            <a:lvl7pPr marL="4608850" indent="0">
              <a:buNone/>
              <a:defRPr sz="1680"/>
            </a:lvl7pPr>
            <a:lvl8pPr marL="5376992" indent="0">
              <a:buNone/>
              <a:defRPr sz="1680"/>
            </a:lvl8pPr>
            <a:lvl9pPr marL="6145134" indent="0">
              <a:buNone/>
              <a:defRPr sz="168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8763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68705" y="613446"/>
            <a:ext cx="13407390" cy="222706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68705" y="3067219"/>
            <a:ext cx="13407390" cy="73106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68705" y="10679259"/>
            <a:ext cx="349758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021891-C08F-454B-8828-BCF0C461CCC4}" type="datetimeFigureOut">
              <a:rPr lang="en-US" smtClean="0"/>
              <a:t>2/1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149215" y="10679259"/>
            <a:ext cx="524637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978515" y="10679259"/>
            <a:ext cx="3497580" cy="6134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01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83F23F-57E6-4D7D-90CC-FA64AE9B62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7827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536283" rtl="0" eaLnBrk="1" latinLnBrk="0" hangingPunct="1">
        <a:lnSpc>
          <a:spcPct val="90000"/>
        </a:lnSpc>
        <a:spcBef>
          <a:spcPct val="0"/>
        </a:spcBef>
        <a:buNone/>
        <a:defRPr sz="739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84071" indent="-384071" algn="l" defTabSz="1536283" rtl="0" eaLnBrk="1" latinLnBrk="0" hangingPunct="1">
        <a:lnSpc>
          <a:spcPct val="90000"/>
        </a:lnSpc>
        <a:spcBef>
          <a:spcPts val="1680"/>
        </a:spcBef>
        <a:buFont typeface="Arial" panose="020B0604020202020204" pitchFamily="34" charset="0"/>
        <a:buChar char="•"/>
        <a:defRPr sz="4704" kern="1200">
          <a:solidFill>
            <a:schemeClr val="tx1"/>
          </a:solidFill>
          <a:latin typeface="+mn-lt"/>
          <a:ea typeface="+mn-ea"/>
          <a:cs typeface="+mn-cs"/>
        </a:defRPr>
      </a:lvl1pPr>
      <a:lvl2pPr marL="1152213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4032" kern="1200">
          <a:solidFill>
            <a:schemeClr val="tx1"/>
          </a:solidFill>
          <a:latin typeface="+mn-lt"/>
          <a:ea typeface="+mn-ea"/>
          <a:cs typeface="+mn-cs"/>
        </a:defRPr>
      </a:lvl2pPr>
      <a:lvl3pPr marL="1920354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360" kern="1200">
          <a:solidFill>
            <a:schemeClr val="tx1"/>
          </a:solidFill>
          <a:latin typeface="+mn-lt"/>
          <a:ea typeface="+mn-ea"/>
          <a:cs typeface="+mn-cs"/>
        </a:defRPr>
      </a:lvl3pPr>
      <a:lvl4pPr marL="2688496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4pPr>
      <a:lvl5pPr marL="3456638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5pPr>
      <a:lvl6pPr marL="4224779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6pPr>
      <a:lvl7pPr marL="4992921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7pPr>
      <a:lvl8pPr marL="5761063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8pPr>
      <a:lvl9pPr marL="6529205" indent="-384071" algn="l" defTabSz="1536283" rtl="0" eaLnBrk="1" latinLnBrk="0" hangingPunct="1">
        <a:lnSpc>
          <a:spcPct val="90000"/>
        </a:lnSpc>
        <a:spcBef>
          <a:spcPts val="840"/>
        </a:spcBef>
        <a:buFont typeface="Arial" panose="020B0604020202020204" pitchFamily="34" charset="0"/>
        <a:buChar char="•"/>
        <a:defRPr sz="30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1pPr>
      <a:lvl2pPr marL="768142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2pPr>
      <a:lvl3pPr marL="1536283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3pPr>
      <a:lvl4pPr marL="2304425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4pPr>
      <a:lvl5pPr marL="3072567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5pPr>
      <a:lvl6pPr marL="3840709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6pPr>
      <a:lvl7pPr marL="4608850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7pPr>
      <a:lvl8pPr marL="5376992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8pPr>
      <a:lvl9pPr marL="6145134" algn="l" defTabSz="1536283" rtl="0" eaLnBrk="1" latinLnBrk="0" hangingPunct="1">
        <a:defRPr sz="30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文本框 87"/>
          <p:cNvSpPr txBox="1"/>
          <p:nvPr/>
        </p:nvSpPr>
        <p:spPr>
          <a:xfrm>
            <a:off x="2117733" y="7625879"/>
            <a:ext cx="11405053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5: Figure </a:t>
            </a:r>
            <a:r>
              <a:rPr lang="en-US" altLang="zh-C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5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lterations of membrane glycerolipid levels (mol%) in developing pods of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FAX1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and </a:t>
            </a:r>
            <a:r>
              <a:rPr lang="en-US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ABCA9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OEs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-week (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per pane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nd 4-week (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er panel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old developing pods were sampled for lipid profiling by ESI-MS/MS. The total lipid levels referred to the total amount of major phospholipid (PC, PE, PG, and PA) and galactolipid (MGDG and DGDG) measured. Values are means ± SE with 5 biological replicates. Capital letters on the top of each panel indicate a significant difference (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1) based on </a:t>
            </a:r>
            <a:r>
              <a:rPr lang="en-US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uncan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-test. PC: phosphatidylcholine; PE: phosphatidylethanolamine; PG: phosphatidylglycerol; PA: phosphatidic acid; MGDG: monogalactosyldiacylglycerol; DGDG: digalactosyldiacylglycerol. </a:t>
            </a:r>
          </a:p>
        </p:txBody>
      </p:sp>
      <p:grpSp>
        <p:nvGrpSpPr>
          <p:cNvPr id="5" name="组合 4"/>
          <p:cNvGrpSpPr/>
          <p:nvPr/>
        </p:nvGrpSpPr>
        <p:grpSpPr>
          <a:xfrm>
            <a:off x="592318" y="1876929"/>
            <a:ext cx="14411053" cy="4957792"/>
            <a:chOff x="578250" y="1933201"/>
            <a:chExt cx="14411053" cy="4957792"/>
          </a:xfrm>
        </p:grpSpPr>
        <p:pic>
          <p:nvPicPr>
            <p:cNvPr id="99" name="图片 98"/>
            <p:cNvPicPr>
              <a:picLocks noChangeAspect="1"/>
            </p:cNvPicPr>
            <p:nvPr/>
          </p:nvPicPr>
          <p:blipFill rotWithShape="1">
            <a:blip r:embed="rId2"/>
            <a:srcRect b="6484"/>
            <a:stretch/>
          </p:blipFill>
          <p:spPr>
            <a:xfrm>
              <a:off x="584299" y="4326137"/>
              <a:ext cx="2383743" cy="2115139"/>
            </a:xfrm>
            <a:prstGeom prst="rect">
              <a:avLst/>
            </a:prstGeom>
          </p:spPr>
        </p:pic>
        <p:pic>
          <p:nvPicPr>
            <p:cNvPr id="2" name="图片 1"/>
            <p:cNvPicPr>
              <a:picLocks noChangeAspect="1"/>
            </p:cNvPicPr>
            <p:nvPr/>
          </p:nvPicPr>
          <p:blipFill rotWithShape="1">
            <a:blip r:embed="rId3"/>
            <a:srcRect b="6411"/>
            <a:stretch/>
          </p:blipFill>
          <p:spPr>
            <a:xfrm>
              <a:off x="578250" y="2065062"/>
              <a:ext cx="2383743" cy="2116796"/>
            </a:xfrm>
            <a:prstGeom prst="rect">
              <a:avLst/>
            </a:prstGeom>
          </p:spPr>
        </p:pic>
        <p:pic>
          <p:nvPicPr>
            <p:cNvPr id="3" name="图片 2"/>
            <p:cNvPicPr>
              <a:picLocks noChangeAspect="1"/>
            </p:cNvPicPr>
            <p:nvPr/>
          </p:nvPicPr>
          <p:blipFill rotWithShape="1">
            <a:blip r:embed="rId4"/>
            <a:srcRect b="6411"/>
            <a:stretch/>
          </p:blipFill>
          <p:spPr>
            <a:xfrm>
              <a:off x="2961993" y="2065062"/>
              <a:ext cx="2383743" cy="2116796"/>
            </a:xfrm>
            <a:prstGeom prst="rect">
              <a:avLst/>
            </a:prstGeom>
          </p:spPr>
        </p:pic>
        <p:pic>
          <p:nvPicPr>
            <p:cNvPr id="89" name="图片 88"/>
            <p:cNvPicPr>
              <a:picLocks noChangeAspect="1"/>
            </p:cNvPicPr>
            <p:nvPr/>
          </p:nvPicPr>
          <p:blipFill rotWithShape="1">
            <a:blip r:embed="rId5"/>
            <a:srcRect b="6411"/>
            <a:stretch/>
          </p:blipFill>
          <p:spPr>
            <a:xfrm>
              <a:off x="5345736" y="2065062"/>
              <a:ext cx="2383743" cy="2116796"/>
            </a:xfrm>
            <a:prstGeom prst="rect">
              <a:avLst/>
            </a:prstGeom>
          </p:spPr>
        </p:pic>
        <p:pic>
          <p:nvPicPr>
            <p:cNvPr id="90" name="图片 89"/>
            <p:cNvPicPr>
              <a:picLocks noChangeAspect="1"/>
            </p:cNvPicPr>
            <p:nvPr/>
          </p:nvPicPr>
          <p:blipFill rotWithShape="1">
            <a:blip r:embed="rId6"/>
            <a:srcRect b="6411"/>
            <a:stretch/>
          </p:blipFill>
          <p:spPr>
            <a:xfrm>
              <a:off x="10177258" y="2065062"/>
              <a:ext cx="2383743" cy="2116796"/>
            </a:xfrm>
            <a:prstGeom prst="rect">
              <a:avLst/>
            </a:prstGeom>
          </p:spPr>
        </p:pic>
        <p:pic>
          <p:nvPicPr>
            <p:cNvPr id="91" name="图片 90"/>
            <p:cNvPicPr>
              <a:picLocks noChangeAspect="1"/>
            </p:cNvPicPr>
            <p:nvPr/>
          </p:nvPicPr>
          <p:blipFill rotWithShape="1">
            <a:blip r:embed="rId7"/>
            <a:srcRect b="6411"/>
            <a:stretch/>
          </p:blipFill>
          <p:spPr>
            <a:xfrm>
              <a:off x="12561001" y="2065062"/>
              <a:ext cx="2383743" cy="2116796"/>
            </a:xfrm>
            <a:prstGeom prst="rect">
              <a:avLst/>
            </a:prstGeom>
          </p:spPr>
        </p:pic>
        <p:pic>
          <p:nvPicPr>
            <p:cNvPr id="92" name="图片 91"/>
            <p:cNvPicPr>
              <a:picLocks noChangeAspect="1"/>
            </p:cNvPicPr>
            <p:nvPr/>
          </p:nvPicPr>
          <p:blipFill rotWithShape="1">
            <a:blip r:embed="rId8"/>
            <a:srcRect b="6411"/>
            <a:stretch/>
          </p:blipFill>
          <p:spPr>
            <a:xfrm>
              <a:off x="7756149" y="2065062"/>
              <a:ext cx="2383743" cy="2116796"/>
            </a:xfrm>
            <a:prstGeom prst="rect">
              <a:avLst/>
            </a:prstGeom>
          </p:spPr>
        </p:pic>
        <p:pic>
          <p:nvPicPr>
            <p:cNvPr id="98" name="图片 97"/>
            <p:cNvPicPr>
              <a:picLocks noChangeAspect="1"/>
            </p:cNvPicPr>
            <p:nvPr/>
          </p:nvPicPr>
          <p:blipFill rotWithShape="1">
            <a:blip r:embed="rId9"/>
            <a:srcRect b="6518"/>
            <a:stretch/>
          </p:blipFill>
          <p:spPr>
            <a:xfrm>
              <a:off x="7756148" y="4326874"/>
              <a:ext cx="2383743" cy="2114402"/>
            </a:xfrm>
            <a:prstGeom prst="rect">
              <a:avLst/>
            </a:prstGeom>
          </p:spPr>
        </p:pic>
        <p:pic>
          <p:nvPicPr>
            <p:cNvPr id="102" name="图片 101"/>
            <p:cNvPicPr>
              <a:picLocks noChangeAspect="1"/>
            </p:cNvPicPr>
            <p:nvPr/>
          </p:nvPicPr>
          <p:blipFill rotWithShape="1">
            <a:blip r:embed="rId10"/>
            <a:srcRect b="5448"/>
            <a:stretch/>
          </p:blipFill>
          <p:spPr>
            <a:xfrm>
              <a:off x="2959124" y="4324880"/>
              <a:ext cx="2383743" cy="2138577"/>
            </a:xfrm>
            <a:prstGeom prst="rect">
              <a:avLst/>
            </a:prstGeom>
          </p:spPr>
        </p:pic>
        <p:pic>
          <p:nvPicPr>
            <p:cNvPr id="103" name="图片 102"/>
            <p:cNvPicPr>
              <a:picLocks noChangeAspect="1"/>
            </p:cNvPicPr>
            <p:nvPr/>
          </p:nvPicPr>
          <p:blipFill rotWithShape="1">
            <a:blip r:embed="rId11"/>
            <a:srcRect b="6429"/>
            <a:stretch/>
          </p:blipFill>
          <p:spPr>
            <a:xfrm>
              <a:off x="5339871" y="4324880"/>
              <a:ext cx="2383743" cy="2116396"/>
            </a:xfrm>
            <a:prstGeom prst="rect">
              <a:avLst/>
            </a:prstGeom>
          </p:spPr>
        </p:pic>
        <p:pic>
          <p:nvPicPr>
            <p:cNvPr id="104" name="图片 103"/>
            <p:cNvPicPr>
              <a:picLocks noChangeAspect="1"/>
            </p:cNvPicPr>
            <p:nvPr/>
          </p:nvPicPr>
          <p:blipFill rotWithShape="1">
            <a:blip r:embed="rId12"/>
            <a:srcRect b="6052"/>
            <a:stretch/>
          </p:blipFill>
          <p:spPr>
            <a:xfrm>
              <a:off x="10174324" y="4316341"/>
              <a:ext cx="2383743" cy="2124935"/>
            </a:xfrm>
            <a:prstGeom prst="rect">
              <a:avLst/>
            </a:prstGeom>
          </p:spPr>
        </p:pic>
        <p:pic>
          <p:nvPicPr>
            <p:cNvPr id="105" name="图片 104"/>
            <p:cNvPicPr>
              <a:picLocks noChangeAspect="1"/>
            </p:cNvPicPr>
            <p:nvPr/>
          </p:nvPicPr>
          <p:blipFill rotWithShape="1">
            <a:blip r:embed="rId13"/>
            <a:srcRect b="6429"/>
            <a:stretch/>
          </p:blipFill>
          <p:spPr>
            <a:xfrm>
              <a:off x="12562936" y="4324880"/>
              <a:ext cx="2383743" cy="2116396"/>
            </a:xfrm>
            <a:prstGeom prst="rect">
              <a:avLst/>
            </a:prstGeom>
          </p:spPr>
        </p:pic>
        <p:sp>
          <p:nvSpPr>
            <p:cNvPr id="17" name="文本框 16"/>
            <p:cNvSpPr txBox="1"/>
            <p:nvPr/>
          </p:nvSpPr>
          <p:spPr>
            <a:xfrm>
              <a:off x="1243419" y="1984608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1685345" y="2001860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6455574" y="2760015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6905041" y="3126134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4077807" y="2463425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3630195" y="2881263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2133486" y="1933201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2581627" y="2010138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4517924" y="2075765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4959394" y="1966939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6008301" y="2109208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7342794" y="3231868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D</a:t>
              </a:r>
            </a:p>
          </p:txBody>
        </p:sp>
        <p:sp>
          <p:nvSpPr>
            <p:cNvPr id="29" name="文本框 28"/>
            <p:cNvSpPr txBox="1"/>
            <p:nvPr/>
          </p:nvSpPr>
          <p:spPr>
            <a:xfrm>
              <a:off x="10842902" y="1934252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11290468" y="2197983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11736741" y="2693232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12177144" y="2724600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13225625" y="2147843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13667095" y="2251568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14113847" y="2388143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14552135" y="2430892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D</a:t>
              </a: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8427602" y="1935840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9753259" y="3435098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8869120" y="3100304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9312849" y="3082510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2126321" y="4469736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2574462" y="4461313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1683954" y="4571401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1242893" y="4729686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3626911" y="4276884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4068471" y="4240043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4513596" y="4213525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4959509" y="4224414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6448257" y="4530702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50" name="文本框 49"/>
            <p:cNvSpPr txBox="1"/>
            <p:nvPr/>
          </p:nvSpPr>
          <p:spPr>
            <a:xfrm>
              <a:off x="6001484" y="4490791"/>
              <a:ext cx="3191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7333798" y="4536081"/>
              <a:ext cx="3086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6897165" y="4524495"/>
              <a:ext cx="3086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53" name="文本框 52"/>
            <p:cNvSpPr txBox="1"/>
            <p:nvPr/>
          </p:nvSpPr>
          <p:spPr>
            <a:xfrm>
              <a:off x="10841296" y="4400781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11291671" y="4683214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55" name="文本框 54"/>
            <p:cNvSpPr txBox="1"/>
            <p:nvPr/>
          </p:nvSpPr>
          <p:spPr>
            <a:xfrm>
              <a:off x="11699184" y="4681554"/>
              <a:ext cx="3783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C</a:t>
              </a:r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12178403" y="4820873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57" name="文本框 56"/>
            <p:cNvSpPr txBox="1"/>
            <p:nvPr/>
          </p:nvSpPr>
          <p:spPr>
            <a:xfrm>
              <a:off x="13674223" y="4294531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  <p:sp>
          <p:nvSpPr>
            <p:cNvPr id="58" name="文本框 57"/>
            <p:cNvSpPr txBox="1"/>
            <p:nvPr/>
          </p:nvSpPr>
          <p:spPr>
            <a:xfrm>
              <a:off x="13224860" y="4260590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59" name="文本框 58"/>
            <p:cNvSpPr txBox="1"/>
            <p:nvPr/>
          </p:nvSpPr>
          <p:spPr>
            <a:xfrm>
              <a:off x="14117000" y="4416066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60" name="文本框 59"/>
            <p:cNvSpPr txBox="1"/>
            <p:nvPr/>
          </p:nvSpPr>
          <p:spPr>
            <a:xfrm>
              <a:off x="14562104" y="4432493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C</a:t>
              </a:r>
            </a:p>
          </p:txBody>
        </p:sp>
        <p:sp>
          <p:nvSpPr>
            <p:cNvPr id="61" name="文本框 60"/>
            <p:cNvSpPr txBox="1"/>
            <p:nvPr/>
          </p:nvSpPr>
          <p:spPr>
            <a:xfrm>
              <a:off x="8425691" y="4233889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</a:t>
              </a:r>
            </a:p>
          </p:txBody>
        </p:sp>
        <p:sp>
          <p:nvSpPr>
            <p:cNvPr id="62" name="文本框 61"/>
            <p:cNvSpPr txBox="1"/>
            <p:nvPr/>
          </p:nvSpPr>
          <p:spPr>
            <a:xfrm>
              <a:off x="8824598" y="5308748"/>
              <a:ext cx="4437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B</a:t>
              </a:r>
            </a:p>
          </p:txBody>
        </p:sp>
        <p:sp>
          <p:nvSpPr>
            <p:cNvPr id="63" name="文本框 62"/>
            <p:cNvSpPr txBox="1"/>
            <p:nvPr/>
          </p:nvSpPr>
          <p:spPr>
            <a:xfrm>
              <a:off x="9268327" y="5251913"/>
              <a:ext cx="44372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B</a:t>
              </a:r>
            </a:p>
          </p:txBody>
        </p:sp>
        <p:sp>
          <p:nvSpPr>
            <p:cNvPr id="64" name="文本框 63"/>
            <p:cNvSpPr txBox="1"/>
            <p:nvPr/>
          </p:nvSpPr>
          <p:spPr>
            <a:xfrm rot="19260655">
              <a:off x="1102367" y="6408999"/>
              <a:ext cx="4188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WT</a:t>
              </a:r>
            </a:p>
          </p:txBody>
        </p:sp>
        <p:sp>
          <p:nvSpPr>
            <p:cNvPr id="65" name="文本框 64"/>
            <p:cNvSpPr txBox="1"/>
            <p:nvPr/>
          </p:nvSpPr>
          <p:spPr>
            <a:xfrm rot="19260655">
              <a:off x="1368062" y="6462089"/>
              <a:ext cx="6853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FAX1-1</a:t>
              </a:r>
            </a:p>
          </p:txBody>
        </p:sp>
        <p:sp>
          <p:nvSpPr>
            <p:cNvPr id="66" name="文本框 65"/>
            <p:cNvSpPr txBox="1"/>
            <p:nvPr/>
          </p:nvSpPr>
          <p:spPr>
            <a:xfrm rot="19260655">
              <a:off x="1720986" y="6490797"/>
              <a:ext cx="7978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BCA9-1</a:t>
              </a:r>
            </a:p>
          </p:txBody>
        </p:sp>
        <p:sp>
          <p:nvSpPr>
            <p:cNvPr id="67" name="文本框 66"/>
            <p:cNvSpPr txBox="1"/>
            <p:nvPr/>
          </p:nvSpPr>
          <p:spPr>
            <a:xfrm rot="19260655">
              <a:off x="1838653" y="6603219"/>
              <a:ext cx="11958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FAX1/ABCA9-1</a:t>
              </a:r>
            </a:p>
          </p:txBody>
        </p:sp>
        <p:sp>
          <p:nvSpPr>
            <p:cNvPr id="68" name="文本框 67"/>
            <p:cNvSpPr txBox="1"/>
            <p:nvPr/>
          </p:nvSpPr>
          <p:spPr>
            <a:xfrm rot="19260655">
              <a:off x="3491793" y="6408999"/>
              <a:ext cx="4188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WT</a:t>
              </a:r>
            </a:p>
          </p:txBody>
        </p:sp>
        <p:sp>
          <p:nvSpPr>
            <p:cNvPr id="69" name="文本框 68"/>
            <p:cNvSpPr txBox="1"/>
            <p:nvPr/>
          </p:nvSpPr>
          <p:spPr>
            <a:xfrm rot="19260655">
              <a:off x="3757593" y="6462611"/>
              <a:ext cx="6826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FAX1-1</a:t>
              </a:r>
            </a:p>
          </p:txBody>
        </p:sp>
        <p:sp>
          <p:nvSpPr>
            <p:cNvPr id="70" name="文本框 69"/>
            <p:cNvSpPr txBox="1"/>
            <p:nvPr/>
          </p:nvSpPr>
          <p:spPr>
            <a:xfrm rot="19260655">
              <a:off x="4106017" y="6491564"/>
              <a:ext cx="7938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BCA9-1</a:t>
              </a:r>
            </a:p>
          </p:txBody>
        </p:sp>
        <p:sp>
          <p:nvSpPr>
            <p:cNvPr id="71" name="文本框 70"/>
            <p:cNvSpPr txBox="1"/>
            <p:nvPr/>
          </p:nvSpPr>
          <p:spPr>
            <a:xfrm rot="19260655">
              <a:off x="4218419" y="6600418"/>
              <a:ext cx="121038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FAX1/ABCA9-1</a:t>
              </a:r>
            </a:p>
          </p:txBody>
        </p:sp>
        <p:sp>
          <p:nvSpPr>
            <p:cNvPr id="72" name="文本框 71"/>
            <p:cNvSpPr txBox="1"/>
            <p:nvPr/>
          </p:nvSpPr>
          <p:spPr>
            <a:xfrm rot="19260655">
              <a:off x="5887344" y="6408998"/>
              <a:ext cx="4188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WT</a:t>
              </a:r>
            </a:p>
          </p:txBody>
        </p:sp>
        <p:sp>
          <p:nvSpPr>
            <p:cNvPr id="73" name="文本框 72"/>
            <p:cNvSpPr txBox="1"/>
            <p:nvPr/>
          </p:nvSpPr>
          <p:spPr>
            <a:xfrm rot="19260655">
              <a:off x="6138231" y="6456307"/>
              <a:ext cx="7153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FAX1-1</a:t>
              </a:r>
            </a:p>
          </p:txBody>
        </p:sp>
        <p:sp>
          <p:nvSpPr>
            <p:cNvPr id="74" name="文本框 73"/>
            <p:cNvSpPr txBox="1"/>
            <p:nvPr/>
          </p:nvSpPr>
          <p:spPr>
            <a:xfrm rot="19260655">
              <a:off x="6491301" y="6485740"/>
              <a:ext cx="8240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BCA9-1</a:t>
              </a:r>
            </a:p>
          </p:txBody>
        </p:sp>
        <p:sp>
          <p:nvSpPr>
            <p:cNvPr id="75" name="文本框 74"/>
            <p:cNvSpPr txBox="1"/>
            <p:nvPr/>
          </p:nvSpPr>
          <p:spPr>
            <a:xfrm rot="19260655">
              <a:off x="6609604" y="6601332"/>
              <a:ext cx="12056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FAX1/ABCA9-1</a:t>
              </a:r>
            </a:p>
          </p:txBody>
        </p:sp>
        <p:sp>
          <p:nvSpPr>
            <p:cNvPr id="76" name="文本框 75"/>
            <p:cNvSpPr txBox="1"/>
            <p:nvPr/>
          </p:nvSpPr>
          <p:spPr>
            <a:xfrm rot="19260655">
              <a:off x="10724549" y="6408998"/>
              <a:ext cx="4188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WT</a:t>
              </a:r>
            </a:p>
          </p:txBody>
        </p:sp>
        <p:sp>
          <p:nvSpPr>
            <p:cNvPr id="77" name="文本框 76"/>
            <p:cNvSpPr txBox="1"/>
            <p:nvPr/>
          </p:nvSpPr>
          <p:spPr>
            <a:xfrm rot="19260655">
              <a:off x="10977347" y="6470366"/>
              <a:ext cx="66605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FAX1-1</a:t>
              </a:r>
            </a:p>
          </p:txBody>
        </p:sp>
        <p:sp>
          <p:nvSpPr>
            <p:cNvPr id="78" name="文本框 77"/>
            <p:cNvSpPr txBox="1"/>
            <p:nvPr/>
          </p:nvSpPr>
          <p:spPr>
            <a:xfrm rot="19260655">
              <a:off x="11323751" y="6484713"/>
              <a:ext cx="8293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BCA9-1</a:t>
              </a:r>
            </a:p>
          </p:txBody>
        </p:sp>
        <p:sp>
          <p:nvSpPr>
            <p:cNvPr id="79" name="文本框 78"/>
            <p:cNvSpPr txBox="1"/>
            <p:nvPr/>
          </p:nvSpPr>
          <p:spPr>
            <a:xfrm rot="19260655">
              <a:off x="11437148" y="6593982"/>
              <a:ext cx="122015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FAX1/ABCA9-1</a:t>
              </a:r>
            </a:p>
          </p:txBody>
        </p:sp>
        <p:sp>
          <p:nvSpPr>
            <p:cNvPr id="80" name="文本框 79"/>
            <p:cNvSpPr txBox="1"/>
            <p:nvPr/>
          </p:nvSpPr>
          <p:spPr>
            <a:xfrm rot="19260655">
              <a:off x="13107944" y="6413222"/>
              <a:ext cx="4188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WT</a:t>
              </a:r>
            </a:p>
          </p:txBody>
        </p:sp>
        <p:sp>
          <p:nvSpPr>
            <p:cNvPr id="81" name="文本框 80"/>
            <p:cNvSpPr txBox="1"/>
            <p:nvPr/>
          </p:nvSpPr>
          <p:spPr>
            <a:xfrm rot="19260655">
              <a:off x="13356329" y="6470724"/>
              <a:ext cx="66251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FAX1-1</a:t>
              </a:r>
            </a:p>
          </p:txBody>
        </p:sp>
        <p:sp>
          <p:nvSpPr>
            <p:cNvPr id="82" name="文本框 81"/>
            <p:cNvSpPr txBox="1"/>
            <p:nvPr/>
          </p:nvSpPr>
          <p:spPr>
            <a:xfrm rot="19260655">
              <a:off x="13708454" y="6495448"/>
              <a:ext cx="7956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BCA9-1</a:t>
              </a:r>
            </a:p>
          </p:txBody>
        </p:sp>
        <p:sp>
          <p:nvSpPr>
            <p:cNvPr id="83" name="文本框 82"/>
            <p:cNvSpPr txBox="1"/>
            <p:nvPr/>
          </p:nvSpPr>
          <p:spPr>
            <a:xfrm rot="19260655">
              <a:off x="13827350" y="6613994"/>
              <a:ext cx="11619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FAX1/ABCA9-1</a:t>
              </a:r>
            </a:p>
          </p:txBody>
        </p:sp>
        <p:sp>
          <p:nvSpPr>
            <p:cNvPr id="84" name="文本框 83"/>
            <p:cNvSpPr txBox="1"/>
            <p:nvPr/>
          </p:nvSpPr>
          <p:spPr>
            <a:xfrm rot="19260655">
              <a:off x="8308775" y="6413222"/>
              <a:ext cx="4188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WT</a:t>
              </a:r>
            </a:p>
          </p:txBody>
        </p:sp>
        <p:sp>
          <p:nvSpPr>
            <p:cNvPr id="85" name="文本框 84"/>
            <p:cNvSpPr txBox="1"/>
            <p:nvPr/>
          </p:nvSpPr>
          <p:spPr>
            <a:xfrm rot="19260655">
              <a:off x="8561940" y="6471871"/>
              <a:ext cx="6565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FAX1-1</a:t>
              </a:r>
            </a:p>
          </p:txBody>
        </p:sp>
        <p:sp>
          <p:nvSpPr>
            <p:cNvPr id="86" name="文本框 85"/>
            <p:cNvSpPr txBox="1"/>
            <p:nvPr/>
          </p:nvSpPr>
          <p:spPr>
            <a:xfrm rot="19260655">
              <a:off x="8913477" y="6489125"/>
              <a:ext cx="80479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ABCA9-1</a:t>
              </a:r>
            </a:p>
          </p:txBody>
        </p:sp>
        <p:sp>
          <p:nvSpPr>
            <p:cNvPr id="87" name="文本框 86"/>
            <p:cNvSpPr txBox="1"/>
            <p:nvPr/>
          </p:nvSpPr>
          <p:spPr>
            <a:xfrm rot="19260655">
              <a:off x="9021587" y="6599266"/>
              <a:ext cx="121466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1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FAX1/ABCA9-1</a:t>
              </a:r>
            </a:p>
          </p:txBody>
        </p:sp>
        <p:sp>
          <p:nvSpPr>
            <p:cNvPr id="93" name="文本框 92"/>
            <p:cNvSpPr txBox="1"/>
            <p:nvPr/>
          </p:nvSpPr>
          <p:spPr>
            <a:xfrm>
              <a:off x="9738649" y="6091242"/>
              <a:ext cx="31865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20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8793693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901</TotalTime>
  <Words>204</Words>
  <Application>Microsoft Office PowerPoint</Application>
  <PresentationFormat>Custom</PresentationFormat>
  <Paragraphs>7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等线</vt:lpstr>
      <vt:lpstr>等线 Light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ai, Guanggin</dc:creator>
  <cp:lastModifiedBy>Jasmine H.</cp:lastModifiedBy>
  <cp:revision>97</cp:revision>
  <cp:lastPrinted>2019-12-09T21:25:57Z</cp:lastPrinted>
  <dcterms:created xsi:type="dcterms:W3CDTF">2019-12-08T22:23:00Z</dcterms:created>
  <dcterms:modified xsi:type="dcterms:W3CDTF">2021-02-12T10:40:07Z</dcterms:modified>
</cp:coreProperties>
</file>